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650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1439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2832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4318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3479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6471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2586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9300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1594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7558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0411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9583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C6FA9C-668B-4865-A1A8-8E6AEFE258C3}" type="datetimeFigureOut">
              <a:rPr lang="fr-FR" smtClean="0"/>
              <a:t>09/1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853F1-C9C8-4D67-9E24-D47499C6CB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3338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68760" y="528652"/>
            <a:ext cx="4077392" cy="2138366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68760" y="3020644"/>
            <a:ext cx="4077392" cy="2133835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68760" y="5508104"/>
            <a:ext cx="4077392" cy="2142896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1757974" y="971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1757974" y="34558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1757974" y="59401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fr-FR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124743" y="7915726"/>
            <a:ext cx="532859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smtClean="0">
                <a:latin typeface="Arial" panose="020B0604020202020204" pitchFamily="34" charset="0"/>
                <a:cs typeface="Arial" panose="020B0604020202020204" pitchFamily="34" charset="0"/>
              </a:rPr>
              <a:t>Figure S3: 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Quantile-quantile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plots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for the flowering time for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the full panel (A), the indica panel (B) and the japonica panel (C)</a:t>
            </a:r>
            <a:endParaRPr lang="fr-FR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695968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2</Words>
  <Application>Microsoft Office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rigitte</dc:creator>
  <cp:lastModifiedBy>Brigitte</cp:lastModifiedBy>
  <cp:revision>4</cp:revision>
  <dcterms:created xsi:type="dcterms:W3CDTF">2014-11-09T17:52:05Z</dcterms:created>
  <dcterms:modified xsi:type="dcterms:W3CDTF">2014-11-09T18:00:48Z</dcterms:modified>
</cp:coreProperties>
</file>